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1A4E5-4D0A-48B3-8DC1-79313207DD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01A08-7DD6-465F-8509-31D95C71D7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EFBD4-1DAE-42E8-BD89-4454AD48FB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617D9-D103-4EE1-B8CD-900B717D62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5C2E1-6F2F-45F8-98A9-0B71CA1ED5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6681F-9419-4726-9F20-175CD6A00B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6D57F-D323-45C2-B4CA-4AF3FCB7D9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DF78F-8A99-4BE2-BB2B-B8C6CAAE29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8CAF9-50A0-4D73-B18A-7EF5263CF3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18832-D769-411B-B206-9274E9AB2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AE96C-F109-46DF-8BE4-77F3840B28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1E53C-5A67-48EF-AF30-2A3EEFD740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276EEF-F506-4AE9-8411-A14E8A6A47E7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26"/>
          <p:cNvGrpSpPr/>
          <p:nvPr/>
        </p:nvGrpSpPr>
        <p:grpSpPr>
          <a:xfrm>
            <a:off x="795240" y="914040"/>
            <a:ext cx="4824360" cy="4963680"/>
            <a:chOff x="795240" y="914040"/>
            <a:chExt cx="4824360" cy="4963680"/>
          </a:xfrm>
        </p:grpSpPr>
        <p:pic>
          <p:nvPicPr>
            <p:cNvPr id="42" name="Picture 28" descr="E:\A张晓梅博士期间文件\中山医学院王海河教授\ZXM实验\石宏顺实验\IHC-PCBP1-肠癌\4508N-DC1-1.tif"/>
            <p:cNvPicPr/>
            <p:nvPr/>
          </p:nvPicPr>
          <p:blipFill>
            <a:blip r:embed="rId1"/>
            <a:stretch/>
          </p:blipFill>
          <p:spPr>
            <a:xfrm>
              <a:off x="1093680" y="107712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0" descr="E:\A张晓梅博士期间文件\中山医学院王海河教授\ZXM实验\石宏顺实验\IHC-PCBP1-肠癌\4514N-DC2-2.tif"/>
            <p:cNvPicPr/>
            <p:nvPr/>
          </p:nvPicPr>
          <p:blipFill>
            <a:blip r:embed="rId2"/>
            <a:stretch/>
          </p:blipFill>
          <p:spPr>
            <a:xfrm>
              <a:off x="2595240" y="107064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1" descr="E:\A张晓梅博士期间文件\中山医学院王海河教授\ZXM实验\石宏顺实验\IHC-PCBP1-肠癌\4521N-DC5.tif"/>
            <p:cNvPicPr/>
            <p:nvPr/>
          </p:nvPicPr>
          <p:blipFill>
            <a:blip r:embed="rId3"/>
            <a:stretch/>
          </p:blipFill>
          <p:spPr>
            <a:xfrm>
              <a:off x="4091760" y="107064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32" descr="E:\A张晓梅博士期间文件\中山医学院王海河教授\ZXM实验\石宏顺实验\IHC-P27-肠癌\4528N-DC9-1.tif"/>
            <p:cNvPicPr/>
            <p:nvPr/>
          </p:nvPicPr>
          <p:blipFill>
            <a:blip r:embed="rId4"/>
            <a:stretch/>
          </p:blipFill>
          <p:spPr>
            <a:xfrm>
              <a:off x="1089000" y="225936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34" descr="E:\A张晓梅博士期间文件\中山医学院王海河教授\ZXM实验\石宏顺实验\IHC-P27-肠癌\4508N-DC1-1.tif"/>
            <p:cNvPicPr/>
            <p:nvPr/>
          </p:nvPicPr>
          <p:blipFill>
            <a:blip r:embed="rId5"/>
            <a:stretch/>
          </p:blipFill>
          <p:spPr>
            <a:xfrm>
              <a:off x="2586600" y="226260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35" descr="E:\A张晓梅博士期间文件\中山医学院王海河教授\ZXM实验\石宏顺实验\IHC-P27-肠癌\4532N-DC10.tif"/>
            <p:cNvPicPr/>
            <p:nvPr/>
          </p:nvPicPr>
          <p:blipFill>
            <a:blip r:embed="rId6"/>
            <a:stretch/>
          </p:blipFill>
          <p:spPr>
            <a:xfrm>
              <a:off x="4088880" y="225828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36" descr="E:\A张晓梅博士期间文件\中山医学院王海河教授\ZXM实验\石宏顺实验\IHC-PCBP1-肠癌\4517T-DT3-1.tif"/>
            <p:cNvPicPr/>
            <p:nvPr/>
          </p:nvPicPr>
          <p:blipFill>
            <a:blip r:embed="rId7"/>
            <a:stretch/>
          </p:blipFill>
          <p:spPr>
            <a:xfrm>
              <a:off x="1080360" y="359316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37" descr="E:\A张晓梅博士期间文件\中山医学院王海河教授\ZXM实验\石宏顺实验\IHC-PCBP1-肠癌\4514T-DT2-3.tif"/>
            <p:cNvPicPr/>
            <p:nvPr/>
          </p:nvPicPr>
          <p:blipFill>
            <a:blip r:embed="rId8"/>
            <a:stretch/>
          </p:blipFill>
          <p:spPr>
            <a:xfrm>
              <a:off x="2585520" y="359388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39" descr="E:\A张晓梅博士期间文件\中山医学院王海河教授\ZXM实验\石宏顺实验\IHC-P27-肠癌\4523T-DT7-2.tif"/>
            <p:cNvPicPr/>
            <p:nvPr/>
          </p:nvPicPr>
          <p:blipFill>
            <a:blip r:embed="rId9"/>
            <a:stretch/>
          </p:blipFill>
          <p:spPr>
            <a:xfrm>
              <a:off x="1081080" y="475596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40" descr="E:\A张晓梅博士期间文件\中山医学院王海河教授\ZXM实验\石宏顺实验\IHC-P27-肠癌\4508T-DT1.tif"/>
            <p:cNvPicPr/>
            <p:nvPr/>
          </p:nvPicPr>
          <p:blipFill>
            <a:blip r:embed="rId10"/>
            <a:stretch/>
          </p:blipFill>
          <p:spPr>
            <a:xfrm>
              <a:off x="2584440" y="475560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41" descr="E:\A张晓梅博士期间文件\中山医学院王海河教授\ZXM实验\石宏顺实验\IHC-P27-肠癌\4532T-DT10-1.tif"/>
            <p:cNvPicPr/>
            <p:nvPr/>
          </p:nvPicPr>
          <p:blipFill>
            <a:blip r:embed="rId11"/>
            <a:stretch/>
          </p:blipFill>
          <p:spPr>
            <a:xfrm>
              <a:off x="4085640" y="4752000"/>
              <a:ext cx="1479240" cy="1109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18"/>
            <p:cNvSpPr/>
            <p:nvPr/>
          </p:nvSpPr>
          <p:spPr>
            <a:xfrm rot="16200000">
              <a:off x="253440" y="1476720"/>
              <a:ext cx="137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BP1 normal col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TextBox 19"/>
            <p:cNvSpPr/>
            <p:nvPr/>
          </p:nvSpPr>
          <p:spPr>
            <a:xfrm rot="16200000">
              <a:off x="344160" y="2682360"/>
              <a:ext cx="117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27 normal colon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TextBox 20"/>
            <p:cNvSpPr/>
            <p:nvPr/>
          </p:nvSpPr>
          <p:spPr>
            <a:xfrm rot="16200000">
              <a:off x="277920" y="4017600"/>
              <a:ext cx="1299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BP1 colon canc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TextBox 21"/>
            <p:cNvSpPr/>
            <p:nvPr/>
          </p:nvSpPr>
          <p:spPr>
            <a:xfrm rot="16200000">
              <a:off x="362880" y="5191920"/>
              <a:ext cx="111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27 colon cance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TextBox 22"/>
            <p:cNvSpPr/>
            <p:nvPr/>
          </p:nvSpPr>
          <p:spPr>
            <a:xfrm>
              <a:off x="2302920" y="1910160"/>
              <a:ext cx="331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                                2                                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TextBox 23"/>
            <p:cNvSpPr/>
            <p:nvPr/>
          </p:nvSpPr>
          <p:spPr>
            <a:xfrm>
              <a:off x="2302920" y="3101760"/>
              <a:ext cx="33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                                1                               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Box 24"/>
            <p:cNvSpPr/>
            <p:nvPr/>
          </p:nvSpPr>
          <p:spPr>
            <a:xfrm>
              <a:off x="2294640" y="4417920"/>
              <a:ext cx="188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                                2   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Box 25"/>
            <p:cNvSpPr/>
            <p:nvPr/>
          </p:nvSpPr>
          <p:spPr>
            <a:xfrm>
              <a:off x="2294640" y="5570640"/>
              <a:ext cx="33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                                1                                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1" name="Text Box 15"/>
          <p:cNvSpPr/>
          <p:nvPr/>
        </p:nvSpPr>
        <p:spPr>
          <a:xfrm>
            <a:off x="468360" y="6461280"/>
            <a:ext cx="6157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8. Expression of PCBP1 and p27 in paired colon cancer samples compared to that in the normal tissu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indicated protein expression level was defined based on the staining intensity  under the same robust  IHC staining condit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6:20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